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339" r:id="rId3"/>
    <p:sldId id="258" r:id="rId4"/>
    <p:sldId id="340" r:id="rId5"/>
    <p:sldId id="341" r:id="rId6"/>
    <p:sldId id="342" r:id="rId7"/>
    <p:sldId id="343" r:id="rId8"/>
    <p:sldId id="344" r:id="rId9"/>
    <p:sldId id="345" r:id="rId10"/>
    <p:sldId id="265" r:id="rId11"/>
    <p:sldId id="263" r:id="rId12"/>
    <p:sldId id="259" r:id="rId13"/>
    <p:sldId id="264" r:id="rId14"/>
    <p:sldId id="261" r:id="rId1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27A84D3-D672-4F6B-B2CE-EB094321DBDB}" v="2" dt="2024-03-15T16:36:32.04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8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7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ian Yu" userId="bac6cbed245afebe" providerId="LiveId" clId="{327A84D3-D672-4F6B-B2CE-EB094321DBDB}"/>
    <pc:docChg chg="custSel delSld modSld sldOrd">
      <pc:chgData name="Jian Yu" userId="bac6cbed245afebe" providerId="LiveId" clId="{327A84D3-D672-4F6B-B2CE-EB094321DBDB}" dt="2024-03-15T17:27:09.700" v="1234"/>
      <pc:docMkLst>
        <pc:docMk/>
      </pc:docMkLst>
      <pc:sldChg chg="modSp mod">
        <pc:chgData name="Jian Yu" userId="bac6cbed245afebe" providerId="LiveId" clId="{327A84D3-D672-4F6B-B2CE-EB094321DBDB}" dt="2024-03-13T18:24:26.396" v="212" actId="1076"/>
        <pc:sldMkLst>
          <pc:docMk/>
          <pc:sldMk cId="1291275157" sldId="256"/>
        </pc:sldMkLst>
        <pc:spChg chg="mod">
          <ac:chgData name="Jian Yu" userId="bac6cbed245afebe" providerId="LiveId" clId="{327A84D3-D672-4F6B-B2CE-EB094321DBDB}" dt="2024-03-13T18:24:26.396" v="212" actId="1076"/>
          <ac:spMkLst>
            <pc:docMk/>
            <pc:sldMk cId="1291275157" sldId="256"/>
            <ac:spMk id="2" creationId="{4FC95316-1AB4-1702-D02F-2771038DACD6}"/>
          </ac:spMkLst>
        </pc:spChg>
      </pc:sldChg>
      <pc:sldChg chg="modSp mod ord">
        <pc:chgData name="Jian Yu" userId="bac6cbed245afebe" providerId="LiveId" clId="{327A84D3-D672-4F6B-B2CE-EB094321DBDB}" dt="2024-03-15T17:06:44.658" v="1048" actId="20577"/>
        <pc:sldMkLst>
          <pc:docMk/>
          <pc:sldMk cId="504484755" sldId="258"/>
        </pc:sldMkLst>
        <pc:spChg chg="mod">
          <ac:chgData name="Jian Yu" userId="bac6cbed245afebe" providerId="LiveId" clId="{327A84D3-D672-4F6B-B2CE-EB094321DBDB}" dt="2024-03-15T17:06:44.658" v="1048" actId="20577"/>
          <ac:spMkLst>
            <pc:docMk/>
            <pc:sldMk cId="504484755" sldId="258"/>
            <ac:spMk id="7" creationId="{4A68ABD7-E015-D775-75F7-D36B48AB1C2B}"/>
          </ac:spMkLst>
        </pc:spChg>
      </pc:sldChg>
      <pc:sldChg chg="modSp mod">
        <pc:chgData name="Jian Yu" userId="bac6cbed245afebe" providerId="LiveId" clId="{327A84D3-D672-4F6B-B2CE-EB094321DBDB}" dt="2024-03-15T17:05:16.481" v="1002" actId="14100"/>
        <pc:sldMkLst>
          <pc:docMk/>
          <pc:sldMk cId="3264763944" sldId="259"/>
        </pc:sldMkLst>
        <pc:spChg chg="mod">
          <ac:chgData name="Jian Yu" userId="bac6cbed245afebe" providerId="LiveId" clId="{327A84D3-D672-4F6B-B2CE-EB094321DBDB}" dt="2024-03-15T17:05:16.481" v="1002" actId="14100"/>
          <ac:spMkLst>
            <pc:docMk/>
            <pc:sldMk cId="3264763944" sldId="259"/>
            <ac:spMk id="4" creationId="{EA2A9FB9-7B18-F228-DE73-986DF7080306}"/>
          </ac:spMkLst>
        </pc:spChg>
      </pc:sldChg>
      <pc:sldChg chg="addSp modSp mod">
        <pc:chgData name="Jian Yu" userId="bac6cbed245afebe" providerId="LiveId" clId="{327A84D3-D672-4F6B-B2CE-EB094321DBDB}" dt="2024-03-15T17:06:18.934" v="1045" actId="20577"/>
        <pc:sldMkLst>
          <pc:docMk/>
          <pc:sldMk cId="1414531175" sldId="261"/>
        </pc:sldMkLst>
        <pc:spChg chg="mod">
          <ac:chgData name="Jian Yu" userId="bac6cbed245afebe" providerId="LiveId" clId="{327A84D3-D672-4F6B-B2CE-EB094321DBDB}" dt="2024-03-15T17:06:18.934" v="1045" actId="20577"/>
          <ac:spMkLst>
            <pc:docMk/>
            <pc:sldMk cId="1414531175" sldId="261"/>
            <ac:spMk id="3" creationId="{72D17B28-4FCC-DF2F-353D-05F57B14E917}"/>
          </ac:spMkLst>
        </pc:spChg>
        <pc:spChg chg="add mod">
          <ac:chgData name="Jian Yu" userId="bac6cbed245afebe" providerId="LiveId" clId="{327A84D3-D672-4F6B-B2CE-EB094321DBDB}" dt="2024-03-15T17:05:35.389" v="1003" actId="1076"/>
          <ac:spMkLst>
            <pc:docMk/>
            <pc:sldMk cId="1414531175" sldId="261"/>
            <ac:spMk id="4" creationId="{4CE5CC79-B0BB-6C05-B455-46A1BBCC716A}"/>
          </ac:spMkLst>
        </pc:spChg>
        <pc:spChg chg="add mod">
          <ac:chgData name="Jian Yu" userId="bac6cbed245afebe" providerId="LiveId" clId="{327A84D3-D672-4F6B-B2CE-EB094321DBDB}" dt="2024-03-15T17:05:48.114" v="1006" actId="1076"/>
          <ac:spMkLst>
            <pc:docMk/>
            <pc:sldMk cId="1414531175" sldId="261"/>
            <ac:spMk id="5" creationId="{212B4CA9-5AD6-4926-12F3-49FA82F984FC}"/>
          </ac:spMkLst>
        </pc:spChg>
        <pc:spChg chg="mod">
          <ac:chgData name="Jian Yu" userId="bac6cbed245afebe" providerId="LiveId" clId="{327A84D3-D672-4F6B-B2CE-EB094321DBDB}" dt="2024-03-15T17:05:44.519" v="1005" actId="1076"/>
          <ac:spMkLst>
            <pc:docMk/>
            <pc:sldMk cId="1414531175" sldId="261"/>
            <ac:spMk id="10" creationId="{A3A61FC2-EB5B-3DA2-6F89-622733656219}"/>
          </ac:spMkLst>
        </pc:spChg>
        <pc:spChg chg="mod">
          <ac:chgData name="Jian Yu" userId="bac6cbed245afebe" providerId="LiveId" clId="{327A84D3-D672-4F6B-B2CE-EB094321DBDB}" dt="2024-03-15T16:37:11.677" v="465" actId="1036"/>
          <ac:spMkLst>
            <pc:docMk/>
            <pc:sldMk cId="1414531175" sldId="261"/>
            <ac:spMk id="11" creationId="{33A5EE19-9802-6CB9-C3DD-DA9C97F11C73}"/>
          </ac:spMkLst>
        </pc:spChg>
        <pc:picChg chg="mod">
          <ac:chgData name="Jian Yu" userId="bac6cbed245afebe" providerId="LiveId" clId="{327A84D3-D672-4F6B-B2CE-EB094321DBDB}" dt="2024-03-15T17:05:44.519" v="1005" actId="1076"/>
          <ac:picMkLst>
            <pc:docMk/>
            <pc:sldMk cId="1414531175" sldId="261"/>
            <ac:picMk id="7" creationId="{3DAD408F-D5C8-C26B-CA83-3CB605A2E437}"/>
          </ac:picMkLst>
        </pc:picChg>
        <pc:picChg chg="mod">
          <ac:chgData name="Jian Yu" userId="bac6cbed245afebe" providerId="LiveId" clId="{327A84D3-D672-4F6B-B2CE-EB094321DBDB}" dt="2024-03-15T16:37:24.560" v="474" actId="1036"/>
          <ac:picMkLst>
            <pc:docMk/>
            <pc:sldMk cId="1414531175" sldId="261"/>
            <ac:picMk id="9" creationId="{B8A86355-2ACA-7EC7-AD5C-0AE086F152B6}"/>
          </ac:picMkLst>
        </pc:picChg>
      </pc:sldChg>
      <pc:sldChg chg="modSp mod">
        <pc:chgData name="Jian Yu" userId="bac6cbed245afebe" providerId="LiveId" clId="{327A84D3-D672-4F6B-B2CE-EB094321DBDB}" dt="2024-03-13T18:22:37.917" v="208" actId="1076"/>
        <pc:sldMkLst>
          <pc:docMk/>
          <pc:sldMk cId="1173294281" sldId="263"/>
        </pc:sldMkLst>
        <pc:spChg chg="mod">
          <ac:chgData name="Jian Yu" userId="bac6cbed245afebe" providerId="LiveId" clId="{327A84D3-D672-4F6B-B2CE-EB094321DBDB}" dt="2024-03-13T18:22:37.917" v="208" actId="1076"/>
          <ac:spMkLst>
            <pc:docMk/>
            <pc:sldMk cId="1173294281" sldId="263"/>
            <ac:spMk id="4" creationId="{97F44C20-9890-FEFA-99E5-4AC15183711A}"/>
          </ac:spMkLst>
        </pc:spChg>
      </pc:sldChg>
      <pc:sldChg chg="modSp mod">
        <pc:chgData name="Jian Yu" userId="bac6cbed245afebe" providerId="LiveId" clId="{327A84D3-D672-4F6B-B2CE-EB094321DBDB}" dt="2024-03-15T17:05:01.515" v="1001" actId="20577"/>
        <pc:sldMkLst>
          <pc:docMk/>
          <pc:sldMk cId="1813142989" sldId="265"/>
        </pc:sldMkLst>
        <pc:spChg chg="mod">
          <ac:chgData name="Jian Yu" userId="bac6cbed245afebe" providerId="LiveId" clId="{327A84D3-D672-4F6B-B2CE-EB094321DBDB}" dt="2024-03-15T17:05:01.515" v="1001" actId="20577"/>
          <ac:spMkLst>
            <pc:docMk/>
            <pc:sldMk cId="1813142989" sldId="265"/>
            <ac:spMk id="2" creationId="{7DFCF0B9-3993-70E2-E7E5-63C43E3835CB}"/>
          </ac:spMkLst>
        </pc:spChg>
      </pc:sldChg>
      <pc:sldChg chg="modSp mod ord">
        <pc:chgData name="Jian Yu" userId="bac6cbed245afebe" providerId="LiveId" clId="{327A84D3-D672-4F6B-B2CE-EB094321DBDB}" dt="2024-03-15T17:27:09.700" v="1234"/>
        <pc:sldMkLst>
          <pc:docMk/>
          <pc:sldMk cId="3727461533" sldId="339"/>
        </pc:sldMkLst>
        <pc:spChg chg="mod">
          <ac:chgData name="Jian Yu" userId="bac6cbed245afebe" providerId="LiveId" clId="{327A84D3-D672-4F6B-B2CE-EB094321DBDB}" dt="2024-03-15T17:04:50.240" v="954" actId="20577"/>
          <ac:spMkLst>
            <pc:docMk/>
            <pc:sldMk cId="3727461533" sldId="339"/>
            <ac:spMk id="2" creationId="{2896F3DF-5963-EEAA-5796-C06BACBE24AC}"/>
          </ac:spMkLst>
        </pc:spChg>
        <pc:spChg chg="mod">
          <ac:chgData name="Jian Yu" userId="bac6cbed245afebe" providerId="LiveId" clId="{327A84D3-D672-4F6B-B2CE-EB094321DBDB}" dt="2024-03-13T18:25:19.427" v="216" actId="1035"/>
          <ac:spMkLst>
            <pc:docMk/>
            <pc:sldMk cId="3727461533" sldId="339"/>
            <ac:spMk id="3" creationId="{6A88D15C-0346-4BD6-C845-233EBC24F8BE}"/>
          </ac:spMkLst>
        </pc:spChg>
        <pc:spChg chg="mod">
          <ac:chgData name="Jian Yu" userId="bac6cbed245afebe" providerId="LiveId" clId="{327A84D3-D672-4F6B-B2CE-EB094321DBDB}" dt="2024-03-13T18:24:50.722" v="214" actId="14100"/>
          <ac:spMkLst>
            <pc:docMk/>
            <pc:sldMk cId="3727461533" sldId="339"/>
            <ac:spMk id="27" creationId="{CDB8CADD-3A9E-3E58-A71A-2F538421A062}"/>
          </ac:spMkLst>
        </pc:spChg>
        <pc:spChg chg="mod">
          <ac:chgData name="Jian Yu" userId="bac6cbed245afebe" providerId="LiveId" clId="{327A84D3-D672-4F6B-B2CE-EB094321DBDB}" dt="2024-03-13T18:29:36.380" v="245" actId="1037"/>
          <ac:spMkLst>
            <pc:docMk/>
            <pc:sldMk cId="3727461533" sldId="339"/>
            <ac:spMk id="28" creationId="{09B20C93-51D0-C862-7EAA-9035DB915323}"/>
          </ac:spMkLst>
        </pc:spChg>
        <pc:spChg chg="mod">
          <ac:chgData name="Jian Yu" userId="bac6cbed245afebe" providerId="LiveId" clId="{327A84D3-D672-4F6B-B2CE-EB094321DBDB}" dt="2024-03-13T18:29:36.380" v="245" actId="1037"/>
          <ac:spMkLst>
            <pc:docMk/>
            <pc:sldMk cId="3727461533" sldId="339"/>
            <ac:spMk id="32" creationId="{08197455-ACEB-B2C4-B9B5-A5E5700768BC}"/>
          </ac:spMkLst>
        </pc:spChg>
        <pc:picChg chg="mod modCrop">
          <ac:chgData name="Jian Yu" userId="bac6cbed245afebe" providerId="LiveId" clId="{327A84D3-D672-4F6B-B2CE-EB094321DBDB}" dt="2024-03-13T18:29:36.380" v="245" actId="1037"/>
          <ac:picMkLst>
            <pc:docMk/>
            <pc:sldMk cId="3727461533" sldId="339"/>
            <ac:picMk id="18" creationId="{B7E358BE-B77C-3C04-6CEA-E349D89AD411}"/>
          </ac:picMkLst>
        </pc:picChg>
      </pc:sldChg>
      <pc:sldChg chg="modSp mod">
        <pc:chgData name="Jian Yu" userId="bac6cbed245afebe" providerId="LiveId" clId="{327A84D3-D672-4F6B-B2CE-EB094321DBDB}" dt="2024-03-15T17:08:50.464" v="1220" actId="14100"/>
        <pc:sldMkLst>
          <pc:docMk/>
          <pc:sldMk cId="2623395589" sldId="340"/>
        </pc:sldMkLst>
        <pc:spChg chg="mod">
          <ac:chgData name="Jian Yu" userId="bac6cbed245afebe" providerId="LiveId" clId="{327A84D3-D672-4F6B-B2CE-EB094321DBDB}" dt="2024-03-15T17:08:50.464" v="1220" actId="14100"/>
          <ac:spMkLst>
            <pc:docMk/>
            <pc:sldMk cId="2623395589" sldId="340"/>
            <ac:spMk id="2" creationId="{7E6E21B5-38E5-3B23-69ED-92881487B664}"/>
          </ac:spMkLst>
        </pc:spChg>
      </pc:sldChg>
      <pc:sldChg chg="modSp mod">
        <pc:chgData name="Jian Yu" userId="bac6cbed245afebe" providerId="LiveId" clId="{327A84D3-D672-4F6B-B2CE-EB094321DBDB}" dt="2024-03-15T17:00:14.811" v="666" actId="20577"/>
        <pc:sldMkLst>
          <pc:docMk/>
          <pc:sldMk cId="1994224963" sldId="341"/>
        </pc:sldMkLst>
        <pc:spChg chg="mod">
          <ac:chgData name="Jian Yu" userId="bac6cbed245afebe" providerId="LiveId" clId="{327A84D3-D672-4F6B-B2CE-EB094321DBDB}" dt="2024-03-15T17:00:14.811" v="666" actId="20577"/>
          <ac:spMkLst>
            <pc:docMk/>
            <pc:sldMk cId="1994224963" sldId="341"/>
            <ac:spMk id="2" creationId="{C1B59DEA-8DDC-C5E5-DE1E-766C9AA4AEC9}"/>
          </ac:spMkLst>
        </pc:spChg>
        <pc:picChg chg="mod">
          <ac:chgData name="Jian Yu" userId="bac6cbed245afebe" providerId="LiveId" clId="{327A84D3-D672-4F6B-B2CE-EB094321DBDB}" dt="2024-03-15T16:33:42.135" v="274" actId="1076"/>
          <ac:picMkLst>
            <pc:docMk/>
            <pc:sldMk cId="1994224963" sldId="341"/>
            <ac:picMk id="5" creationId="{13FEDD19-82FD-A328-805E-EAE2633FCF19}"/>
          </ac:picMkLst>
        </pc:picChg>
      </pc:sldChg>
      <pc:sldChg chg="modSp mod">
        <pc:chgData name="Jian Yu" userId="bac6cbed245afebe" providerId="LiveId" clId="{327A84D3-D672-4F6B-B2CE-EB094321DBDB}" dt="2024-03-15T17:01:16.591" v="724" actId="14100"/>
        <pc:sldMkLst>
          <pc:docMk/>
          <pc:sldMk cId="2816285660" sldId="342"/>
        </pc:sldMkLst>
        <pc:spChg chg="mod">
          <ac:chgData name="Jian Yu" userId="bac6cbed245afebe" providerId="LiveId" clId="{327A84D3-D672-4F6B-B2CE-EB094321DBDB}" dt="2024-03-15T17:01:16.591" v="724" actId="14100"/>
          <ac:spMkLst>
            <pc:docMk/>
            <pc:sldMk cId="2816285660" sldId="342"/>
            <ac:spMk id="2" creationId="{E1973B34-2F15-1F46-828D-D87BBD20FFEB}"/>
          </ac:spMkLst>
        </pc:spChg>
        <pc:picChg chg="mod">
          <ac:chgData name="Jian Yu" userId="bac6cbed245afebe" providerId="LiveId" clId="{327A84D3-D672-4F6B-B2CE-EB094321DBDB}" dt="2024-03-15T16:33:52.395" v="276" actId="14100"/>
          <ac:picMkLst>
            <pc:docMk/>
            <pc:sldMk cId="2816285660" sldId="342"/>
            <ac:picMk id="5" creationId="{8717D1A5-A5A1-5A69-EB01-A0FED44E323E}"/>
          </ac:picMkLst>
        </pc:picChg>
      </pc:sldChg>
      <pc:sldChg chg="modSp mod ord">
        <pc:chgData name="Jian Yu" userId="bac6cbed245afebe" providerId="LiveId" clId="{327A84D3-D672-4F6B-B2CE-EB094321DBDB}" dt="2024-03-15T17:01:49.213" v="745" actId="20577"/>
        <pc:sldMkLst>
          <pc:docMk/>
          <pc:sldMk cId="3077306661" sldId="343"/>
        </pc:sldMkLst>
        <pc:spChg chg="mod">
          <ac:chgData name="Jian Yu" userId="bac6cbed245afebe" providerId="LiveId" clId="{327A84D3-D672-4F6B-B2CE-EB094321DBDB}" dt="2024-03-15T17:01:49.213" v="745" actId="20577"/>
          <ac:spMkLst>
            <pc:docMk/>
            <pc:sldMk cId="3077306661" sldId="343"/>
            <ac:spMk id="6" creationId="{E9AA3198-7D15-76DE-49C2-05816EBAD21C}"/>
          </ac:spMkLst>
        </pc:spChg>
      </pc:sldChg>
      <pc:sldChg chg="modSp mod ord">
        <pc:chgData name="Jian Yu" userId="bac6cbed245afebe" providerId="LiveId" clId="{327A84D3-D672-4F6B-B2CE-EB094321DBDB}" dt="2024-03-15T17:02:49.494" v="769" actId="1076"/>
        <pc:sldMkLst>
          <pc:docMk/>
          <pc:sldMk cId="2940812592" sldId="344"/>
        </pc:sldMkLst>
        <pc:spChg chg="mod">
          <ac:chgData name="Jian Yu" userId="bac6cbed245afebe" providerId="LiveId" clId="{327A84D3-D672-4F6B-B2CE-EB094321DBDB}" dt="2024-03-15T17:02:49.494" v="769" actId="1076"/>
          <ac:spMkLst>
            <pc:docMk/>
            <pc:sldMk cId="2940812592" sldId="344"/>
            <ac:spMk id="2" creationId="{6C176942-7928-29D7-2ED5-169403AB4EAE}"/>
          </ac:spMkLst>
        </pc:spChg>
      </pc:sldChg>
      <pc:sldChg chg="modSp mod ord">
        <pc:chgData name="Jian Yu" userId="bac6cbed245afebe" providerId="LiveId" clId="{327A84D3-D672-4F6B-B2CE-EB094321DBDB}" dt="2024-03-15T17:04:14.615" v="877" actId="1076"/>
        <pc:sldMkLst>
          <pc:docMk/>
          <pc:sldMk cId="24750663" sldId="345"/>
        </pc:sldMkLst>
        <pc:spChg chg="mod">
          <ac:chgData name="Jian Yu" userId="bac6cbed245afebe" providerId="LiveId" clId="{327A84D3-D672-4F6B-B2CE-EB094321DBDB}" dt="2024-03-15T17:04:14.615" v="877" actId="1076"/>
          <ac:spMkLst>
            <pc:docMk/>
            <pc:sldMk cId="24750663" sldId="345"/>
            <ac:spMk id="2" creationId="{4AC5ACD0-117A-B663-4D92-9614E83985A5}"/>
          </ac:spMkLst>
        </pc:spChg>
        <pc:picChg chg="mod">
          <ac:chgData name="Jian Yu" userId="bac6cbed245afebe" providerId="LiveId" clId="{327A84D3-D672-4F6B-B2CE-EB094321DBDB}" dt="2024-03-15T17:04:03.521" v="876" actId="1076"/>
          <ac:picMkLst>
            <pc:docMk/>
            <pc:sldMk cId="24750663" sldId="345"/>
            <ac:picMk id="5" creationId="{2ED0A3A9-46CF-34A0-AC3B-B8F44CE47E08}"/>
          </ac:picMkLst>
        </pc:picChg>
      </pc:sldChg>
      <pc:sldChg chg="del">
        <pc:chgData name="Jian Yu" userId="bac6cbed245afebe" providerId="LiveId" clId="{327A84D3-D672-4F6B-B2CE-EB094321DBDB}" dt="2024-03-13T18:21:27.301" v="131" actId="2696"/>
        <pc:sldMkLst>
          <pc:docMk/>
          <pc:sldMk cId="167367303" sldId="346"/>
        </pc:sldMkLst>
      </pc:sldChg>
      <pc:sldChg chg="del">
        <pc:chgData name="Jian Yu" userId="bac6cbed245afebe" providerId="LiveId" clId="{327A84D3-D672-4F6B-B2CE-EB094321DBDB}" dt="2024-03-15T16:58:11.631" v="517" actId="2696"/>
        <pc:sldMkLst>
          <pc:docMk/>
          <pc:sldMk cId="3736704960" sldId="34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64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290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403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462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107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143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657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927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38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13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777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F4147-8963-4155-BB64-E57BDDF7EB2C}" type="datetimeFigureOut">
              <a:rPr lang="en-US" smtClean="0"/>
              <a:t>3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B3A03-5A0C-456A-95F0-395A143C8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115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5.png"/><Relationship Id="rId7" Type="http://schemas.openxmlformats.org/officeDocument/2006/relationships/image" Target="../media/image18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9" Type="http://schemas.openxmlformats.org/officeDocument/2006/relationships/image" Target="../media/image1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95316-1AB4-1702-D02F-2771038DAC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58264" y="2203612"/>
            <a:ext cx="6141472" cy="1245704"/>
          </a:xfrm>
        </p:spPr>
        <p:txBody>
          <a:bodyPr>
            <a:normAutofit fontScale="90000"/>
          </a:bodyPr>
          <a:lstStyle/>
          <a:p>
            <a:r>
              <a:rPr lang="en-US" dirty="0"/>
              <a:t>Primary data 2</a:t>
            </a:r>
            <a:br>
              <a:rPr lang="en-US" dirty="0"/>
            </a:br>
            <a:br>
              <a:rPr lang="en-US" dirty="0"/>
            </a:br>
            <a:r>
              <a:rPr lang="en-US" dirty="0"/>
              <a:t>film scans, notebook scans, gel images </a:t>
            </a:r>
          </a:p>
        </p:txBody>
      </p:sp>
      <p:sp>
        <p:nvSpPr>
          <p:cNvPr id="4" name="Subtitle 2">
            <a:extLst>
              <a:ext uri="{FF2B5EF4-FFF2-40B4-BE49-F238E27FC236}">
                <a16:creationId xmlns:a16="http://schemas.microsoft.com/office/drawing/2014/main" id="{B30D13B7-148E-038D-297A-C5F862501BEA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>
          <a:xfrm>
            <a:off x="553278" y="3963160"/>
            <a:ext cx="5410200" cy="1102899"/>
          </a:xfrm>
          <a:prstGeom prst="rect">
            <a:avLst/>
          </a:prstGeom>
        </p:spPr>
        <p:txBody>
          <a:bodyPr>
            <a:normAutofit fontScale="92500"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Article ID 10.1371/journal.pone.004318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12751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CF0B9-3993-70E2-E7E5-63C43E383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6956" y="825039"/>
            <a:ext cx="5915025" cy="1767417"/>
          </a:xfrm>
        </p:spPr>
        <p:txBody>
          <a:bodyPr/>
          <a:lstStyle/>
          <a:p>
            <a:r>
              <a:rPr lang="en-US" dirty="0"/>
              <a:t>Additional primary data on Figures Fig 3A, S2 and 4A.</a:t>
            </a:r>
          </a:p>
        </p:txBody>
      </p:sp>
    </p:spTree>
    <p:extLst>
      <p:ext uri="{BB962C8B-B14F-4D97-AF65-F5344CB8AC3E}">
        <p14:creationId xmlns:p14="http://schemas.microsoft.com/office/powerpoint/2010/main" val="18131429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345BDB5-FAB2-F5A8-2D90-C09802D50A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431" b="13087"/>
          <a:stretch/>
        </p:blipFill>
        <p:spPr>
          <a:xfrm>
            <a:off x="936970" y="2030581"/>
            <a:ext cx="4976996" cy="276973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72F2C14-1CA8-5A54-8AF1-728E7163BC9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103" t="8718" r="2227" b="25318"/>
          <a:stretch/>
        </p:blipFill>
        <p:spPr>
          <a:xfrm>
            <a:off x="936970" y="5282774"/>
            <a:ext cx="4969932" cy="231309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7F44C20-9890-FEFA-99E5-4AC15183711A}"/>
              </a:ext>
            </a:extLst>
          </p:cNvPr>
          <p:cNvSpPr txBox="1"/>
          <p:nvPr/>
        </p:nvSpPr>
        <p:spPr>
          <a:xfrm>
            <a:off x="724027" y="819858"/>
            <a:ext cx="509375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dirty="0">
                <a:latin typeface="ArialMT"/>
              </a:rPr>
              <a:t>Fig 3A, HCT, and HT 29, </a:t>
            </a:r>
          </a:p>
          <a:p>
            <a:pPr algn="l"/>
            <a:r>
              <a:rPr lang="en-US" dirty="0">
                <a:latin typeface="ArialMT"/>
              </a:rPr>
              <a:t>p-AKT and Total AKT</a:t>
            </a:r>
          </a:p>
        </p:txBody>
      </p:sp>
    </p:spTree>
    <p:extLst>
      <p:ext uri="{BB962C8B-B14F-4D97-AF65-F5344CB8AC3E}">
        <p14:creationId xmlns:p14="http://schemas.microsoft.com/office/powerpoint/2010/main" val="117329428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0B75CB2-1DB6-7CB6-8347-0F922429AE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688" t="22755"/>
          <a:stretch/>
        </p:blipFill>
        <p:spPr>
          <a:xfrm>
            <a:off x="344821" y="1839230"/>
            <a:ext cx="2919199" cy="19677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A2A9FB9-7B18-F228-DE73-986DF7080306}"/>
              </a:ext>
            </a:extLst>
          </p:cNvPr>
          <p:cNvSpPr txBox="1"/>
          <p:nvPr/>
        </p:nvSpPr>
        <p:spPr>
          <a:xfrm>
            <a:off x="354910" y="854157"/>
            <a:ext cx="618646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dirty="0">
                <a:latin typeface="ArialMT"/>
              </a:rPr>
              <a:t>Fig 3A, HCT, and HT 29, p-FOXO3A, Total FOXO3A, B-actio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9F8DBC3-648F-70CC-77E5-5FA8B9F762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097" b="1348"/>
          <a:stretch/>
        </p:blipFill>
        <p:spPr>
          <a:xfrm>
            <a:off x="3429000" y="1610716"/>
            <a:ext cx="3112379" cy="219623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9FC776B-F696-0C6F-4AA9-80E6F14FD4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9000" y="3976353"/>
            <a:ext cx="2751765" cy="229166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A5AC54B-FBF8-3765-7607-8C70C4F1762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45462"/>
          <a:stretch/>
        </p:blipFill>
        <p:spPr>
          <a:xfrm>
            <a:off x="1029314" y="6960390"/>
            <a:ext cx="2114845" cy="129887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EDF4F77-6187-A3FC-941E-BC19D6D234D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32636"/>
          <a:stretch/>
        </p:blipFill>
        <p:spPr>
          <a:xfrm>
            <a:off x="3713843" y="6982010"/>
            <a:ext cx="1971950" cy="146957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1AC252D-30C0-E2E6-C5C4-56C1ECF58A8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90359" y="4159023"/>
            <a:ext cx="1829055" cy="1657581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32132743-0AC0-92CA-CFBB-A229DF940367}"/>
              </a:ext>
            </a:extLst>
          </p:cNvPr>
          <p:cNvSpPr/>
          <p:nvPr/>
        </p:nvSpPr>
        <p:spPr>
          <a:xfrm>
            <a:off x="4375411" y="5158801"/>
            <a:ext cx="1805354" cy="3276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CFE121B-E3CB-F95A-B45C-C2D80A7E3DAF}"/>
              </a:ext>
            </a:extLst>
          </p:cNvPr>
          <p:cNvSpPr/>
          <p:nvPr/>
        </p:nvSpPr>
        <p:spPr>
          <a:xfrm>
            <a:off x="1508512" y="4646593"/>
            <a:ext cx="1805354" cy="3276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D623933-2C51-0625-5E79-50E4C92999D6}"/>
              </a:ext>
            </a:extLst>
          </p:cNvPr>
          <p:cNvSpPr txBox="1"/>
          <p:nvPr/>
        </p:nvSpPr>
        <p:spPr>
          <a:xfrm>
            <a:off x="344821" y="4475853"/>
            <a:ext cx="98797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Total- FOXA3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F4B4BDB-5FA8-DB74-DB4B-BD929BDFCE3F}"/>
              </a:ext>
            </a:extLst>
          </p:cNvPr>
          <p:cNvSpPr txBox="1"/>
          <p:nvPr/>
        </p:nvSpPr>
        <p:spPr>
          <a:xfrm>
            <a:off x="354910" y="6421836"/>
            <a:ext cx="1805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B-actin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47639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7927AAC-45AC-5FC5-7FCA-CAA1D2883B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54"/>
          <a:stretch/>
        </p:blipFill>
        <p:spPr>
          <a:xfrm>
            <a:off x="1109282" y="1655624"/>
            <a:ext cx="3959267" cy="370687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7A0CB37-03FC-B42E-C9B2-9F34DD5AC3E1}"/>
              </a:ext>
            </a:extLst>
          </p:cNvPr>
          <p:cNvSpPr txBox="1"/>
          <p:nvPr/>
        </p:nvSpPr>
        <p:spPr>
          <a:xfrm>
            <a:off x="517480" y="584196"/>
            <a:ext cx="49821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dirty="0">
                <a:latin typeface="ArialMT"/>
              </a:rPr>
              <a:t>Fig S2 related to 3A, p-p65 and total p-65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BBE0E3F-6E83-D53B-9A74-69FE58254F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9210" y="5899332"/>
            <a:ext cx="4619413" cy="218608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DB6C978-E39C-C1E1-C4D2-E6FF6944FF14}"/>
              </a:ext>
            </a:extLst>
          </p:cNvPr>
          <p:cNvSpPr txBox="1"/>
          <p:nvPr/>
        </p:nvSpPr>
        <p:spPr>
          <a:xfrm>
            <a:off x="822280" y="1305694"/>
            <a:ext cx="21176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p-p65 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0A47A96-3751-8DDD-2014-5624352C0721}"/>
              </a:ext>
            </a:extLst>
          </p:cNvPr>
          <p:cNvSpPr txBox="1"/>
          <p:nvPr/>
        </p:nvSpPr>
        <p:spPr>
          <a:xfrm>
            <a:off x="730160" y="5418334"/>
            <a:ext cx="21176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Total-p65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629144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2D17B28-4FCC-DF2F-353D-05F57B14E917}"/>
              </a:ext>
            </a:extLst>
          </p:cNvPr>
          <p:cNvSpPr txBox="1"/>
          <p:nvPr/>
        </p:nvSpPr>
        <p:spPr>
          <a:xfrm>
            <a:off x="637908" y="634395"/>
            <a:ext cx="443973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dirty="0">
                <a:latin typeface="ArialMT"/>
              </a:rPr>
              <a:t>Fig 4A Short and long exposure, </a:t>
            </a:r>
          </a:p>
          <a:p>
            <a:pPr algn="l"/>
            <a:r>
              <a:rPr lang="en-US" dirty="0">
                <a:latin typeface="ArialMT"/>
              </a:rPr>
              <a:t> IP on the left (lane 1-4), and input on the right (lane 5-8)</a:t>
            </a:r>
          </a:p>
        </p:txBody>
      </p:sp>
      <p:pic>
        <p:nvPicPr>
          <p:cNvPr id="7" name="Picture 6" descr="A close-up of a test tube&#10;&#10;Description automatically generated">
            <a:extLst>
              <a:ext uri="{FF2B5EF4-FFF2-40B4-BE49-F238E27FC236}">
                <a16:creationId xmlns:a16="http://schemas.microsoft.com/office/drawing/2014/main" id="{3DAD408F-D5C8-C26B-CA83-3CB605A2E4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642" y="4392322"/>
            <a:ext cx="5183763" cy="4274176"/>
          </a:xfrm>
          <a:prstGeom prst="rect">
            <a:avLst/>
          </a:prstGeom>
        </p:spPr>
      </p:pic>
      <p:pic>
        <p:nvPicPr>
          <p:cNvPr id="9" name="Picture 8" descr="A close up of a line&#10;&#10;Description automatically generated">
            <a:extLst>
              <a:ext uri="{FF2B5EF4-FFF2-40B4-BE49-F238E27FC236}">
                <a16:creationId xmlns:a16="http://schemas.microsoft.com/office/drawing/2014/main" id="{B8A86355-2ACA-7EC7-AD5C-0AE086F152B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69" y="1747947"/>
            <a:ext cx="5183763" cy="2412098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A3A61FC2-EB5B-3DA2-6F89-622733656219}"/>
              </a:ext>
            </a:extLst>
          </p:cNvPr>
          <p:cNvSpPr/>
          <p:nvPr/>
        </p:nvSpPr>
        <p:spPr>
          <a:xfrm>
            <a:off x="1197593" y="6006118"/>
            <a:ext cx="2232737" cy="1046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3A5EE19-9802-6CB9-C3DD-DA9C97F11C73}"/>
              </a:ext>
            </a:extLst>
          </p:cNvPr>
          <p:cNvSpPr/>
          <p:nvPr/>
        </p:nvSpPr>
        <p:spPr>
          <a:xfrm>
            <a:off x="935682" y="2775644"/>
            <a:ext cx="2493318" cy="11319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E5CC79-B0BB-6C05-B455-46A1BBCC716A}"/>
              </a:ext>
            </a:extLst>
          </p:cNvPr>
          <p:cNvSpPr txBox="1"/>
          <p:nvPr/>
        </p:nvSpPr>
        <p:spPr>
          <a:xfrm>
            <a:off x="5609435" y="2452478"/>
            <a:ext cx="141837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Short exposure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2B4CA9-5AD6-4926-12F3-49FA82F984FC}"/>
              </a:ext>
            </a:extLst>
          </p:cNvPr>
          <p:cNvSpPr txBox="1"/>
          <p:nvPr/>
        </p:nvSpPr>
        <p:spPr>
          <a:xfrm>
            <a:off x="5434070" y="6406372"/>
            <a:ext cx="15937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Long expos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45311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6F3DF-5963-EEAA-5796-C06BACBE24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321943"/>
            <a:ext cx="5915025" cy="449727"/>
          </a:xfrm>
        </p:spPr>
        <p:txBody>
          <a:bodyPr>
            <a:normAutofit fontScale="90000"/>
          </a:bodyPr>
          <a:lstStyle/>
          <a:p>
            <a:r>
              <a:rPr lang="en-US" sz="2400" dirty="0"/>
              <a:t>Fig. 6B Correction.  Film scan and later experiment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E87998B-2674-781C-D67D-FC6710576C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4357"/>
          <a:stretch/>
        </p:blipFill>
        <p:spPr>
          <a:xfrm>
            <a:off x="1434268" y="915974"/>
            <a:ext cx="4656911" cy="253569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7E358BE-B77C-3C04-6CEA-E349D89AD41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b="1704"/>
          <a:stretch/>
        </p:blipFill>
        <p:spPr>
          <a:xfrm flipV="1">
            <a:off x="1527010" y="6776581"/>
            <a:ext cx="2756586" cy="196213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EE1F5F9-D618-8B05-EAB4-6BFC5422B4F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5897"/>
          <a:stretch/>
        </p:blipFill>
        <p:spPr>
          <a:xfrm>
            <a:off x="1365829" y="3546500"/>
            <a:ext cx="4586501" cy="3017814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CDB8CADD-3A9E-3E58-A71A-2F538421A062}"/>
              </a:ext>
            </a:extLst>
          </p:cNvPr>
          <p:cNvSpPr/>
          <p:nvPr/>
        </p:nvSpPr>
        <p:spPr>
          <a:xfrm>
            <a:off x="2943616" y="1589601"/>
            <a:ext cx="1350088" cy="8259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9B20C93-51D0-C862-7EAA-9035DB915323}"/>
              </a:ext>
            </a:extLst>
          </p:cNvPr>
          <p:cNvSpPr/>
          <p:nvPr/>
        </p:nvSpPr>
        <p:spPr>
          <a:xfrm>
            <a:off x="1569662" y="7690579"/>
            <a:ext cx="989459" cy="6589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40AA7A5-8E89-54CD-77D7-5B90EE6BC43B}"/>
              </a:ext>
            </a:extLst>
          </p:cNvPr>
          <p:cNvSpPr txBox="1"/>
          <p:nvPr/>
        </p:nvSpPr>
        <p:spPr>
          <a:xfrm>
            <a:off x="172184" y="1589601"/>
            <a:ext cx="17253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PUM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EF2A371-1BC7-480F-03D2-2F99581BAA63}"/>
              </a:ext>
            </a:extLst>
          </p:cNvPr>
          <p:cNvSpPr txBox="1"/>
          <p:nvPr/>
        </p:nvSpPr>
        <p:spPr>
          <a:xfrm>
            <a:off x="221424" y="4493350"/>
            <a:ext cx="17253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Mcl-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197455-ACEB-B2C4-B9B5-A5E5700768BC}"/>
              </a:ext>
            </a:extLst>
          </p:cNvPr>
          <p:cNvSpPr txBox="1"/>
          <p:nvPr/>
        </p:nvSpPr>
        <p:spPr>
          <a:xfrm>
            <a:off x="196372" y="7896246"/>
            <a:ext cx="9958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A88D15C-0346-4BD6-C845-233EBC24F8BE}"/>
              </a:ext>
            </a:extLst>
          </p:cNvPr>
          <p:cNvSpPr/>
          <p:nvPr/>
        </p:nvSpPr>
        <p:spPr>
          <a:xfrm>
            <a:off x="1632293" y="4652964"/>
            <a:ext cx="1458877" cy="6325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</p:spTree>
    <p:extLst>
      <p:ext uri="{BB962C8B-B14F-4D97-AF65-F5344CB8AC3E}">
        <p14:creationId xmlns:p14="http://schemas.microsoft.com/office/powerpoint/2010/main" val="3727461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4736B469-7676-6B5C-602B-D5F5B4C87E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4245" y="1330832"/>
            <a:ext cx="4838857" cy="3706358"/>
          </a:xfrm>
          <a:prstGeom prst="rect">
            <a:avLst/>
          </a:prstGeom>
        </p:spPr>
      </p:pic>
      <p:pic>
        <p:nvPicPr>
          <p:cNvPr id="5" name="Picture 4" descr="A close-up of a rectangular object&#10;&#10;Description automatically generated">
            <a:extLst>
              <a:ext uri="{FF2B5EF4-FFF2-40B4-BE49-F238E27FC236}">
                <a16:creationId xmlns:a16="http://schemas.microsoft.com/office/drawing/2014/main" id="{AFB00E95-3967-726A-F04B-E0F90B23D4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4245" y="5194411"/>
            <a:ext cx="4947355" cy="378946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A68ABD7-E015-D775-75F7-D36B48AB1C2B}"/>
              </a:ext>
            </a:extLst>
          </p:cNvPr>
          <p:cNvSpPr txBox="1"/>
          <p:nvPr/>
        </p:nvSpPr>
        <p:spPr>
          <a:xfrm>
            <a:off x="476862" y="499835"/>
            <a:ext cx="494735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dirty="0">
                <a:latin typeface="ArialMT"/>
              </a:rPr>
              <a:t>Fig 1C PUMA and GAPDH, RT PCR Gel images, 0/4/8/12/24/36h, from right to left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6C0B387-883E-C944-1CCE-B41C15EB4F8C}"/>
              </a:ext>
            </a:extLst>
          </p:cNvPr>
          <p:cNvSpPr/>
          <p:nvPr/>
        </p:nvSpPr>
        <p:spPr>
          <a:xfrm>
            <a:off x="1979111" y="2839699"/>
            <a:ext cx="1459492" cy="6886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265AE9C-67F4-8BB8-383B-0A5336E71AB6}"/>
              </a:ext>
            </a:extLst>
          </p:cNvPr>
          <p:cNvSpPr/>
          <p:nvPr/>
        </p:nvSpPr>
        <p:spPr>
          <a:xfrm>
            <a:off x="1894951" y="7455359"/>
            <a:ext cx="1534049" cy="7156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9CF574-CE4A-D4C6-B42E-C8A5D78F81D8}"/>
              </a:ext>
            </a:extLst>
          </p:cNvPr>
          <p:cNvSpPr txBox="1"/>
          <p:nvPr/>
        </p:nvSpPr>
        <p:spPr>
          <a:xfrm>
            <a:off x="263046" y="2503473"/>
            <a:ext cx="11211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PUMA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1F7AB7B-408C-80F8-F8A1-84C7102802CC}"/>
              </a:ext>
            </a:extLst>
          </p:cNvPr>
          <p:cNvSpPr txBox="1"/>
          <p:nvPr/>
        </p:nvSpPr>
        <p:spPr>
          <a:xfrm>
            <a:off x="263045" y="7628502"/>
            <a:ext cx="11211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MT"/>
              </a:rPr>
              <a:t>GAPD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44847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6E21B5-38E5-3B23-69ED-92881487B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6196" y="598275"/>
            <a:ext cx="5915025" cy="904848"/>
          </a:xfrm>
        </p:spPr>
        <p:txBody>
          <a:bodyPr>
            <a:normAutofit/>
          </a:bodyPr>
          <a:lstStyle/>
          <a:p>
            <a:r>
              <a:rPr lang="en-US" sz="2000" b="1" dirty="0"/>
              <a:t>Fig. 6A. 2010, notebook scan on mouse experiments.</a:t>
            </a:r>
            <a:br>
              <a:rPr lang="en-US" sz="2000" b="1" dirty="0"/>
            </a:br>
            <a:r>
              <a:rPr lang="en-US" sz="2000" b="1" dirty="0"/>
              <a:t>After q-PCR in Fig. 1C</a:t>
            </a:r>
          </a:p>
        </p:txBody>
      </p:sp>
      <p:pic>
        <p:nvPicPr>
          <p:cNvPr id="5" name="Content Placeholder 4" descr="A graph on a white sheet&#10;&#10;Description automatically generated">
            <a:extLst>
              <a:ext uri="{FF2B5EF4-FFF2-40B4-BE49-F238E27FC236}">
                <a16:creationId xmlns:a16="http://schemas.microsoft.com/office/drawing/2014/main" id="{CBC01652-923B-A618-6EDE-135BAB388C4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615" y="1689719"/>
            <a:ext cx="5398188" cy="7197584"/>
          </a:xfrm>
        </p:spPr>
      </p:pic>
    </p:spTree>
    <p:extLst>
      <p:ext uri="{BB962C8B-B14F-4D97-AF65-F5344CB8AC3E}">
        <p14:creationId xmlns:p14="http://schemas.microsoft.com/office/powerpoint/2010/main" val="26233955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59DEA-8DDC-C5E5-DE1E-766C9AA4AE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1696" y="399155"/>
            <a:ext cx="5915025" cy="1016286"/>
          </a:xfrm>
        </p:spPr>
        <p:txBody>
          <a:bodyPr>
            <a:normAutofit/>
          </a:bodyPr>
          <a:lstStyle/>
          <a:p>
            <a:r>
              <a:rPr lang="en-US" sz="2000" b="1" dirty="0"/>
              <a:t>Fig. 6A.  2010 notebook scan, buffer prep for mouse experiments</a:t>
            </a:r>
          </a:p>
        </p:txBody>
      </p:sp>
      <p:pic>
        <p:nvPicPr>
          <p:cNvPr id="5" name="Content Placeholder 4" descr="A piece of paper with a graph&#10;&#10;Description automatically generated">
            <a:extLst>
              <a:ext uri="{FF2B5EF4-FFF2-40B4-BE49-F238E27FC236}">
                <a16:creationId xmlns:a16="http://schemas.microsoft.com/office/drawing/2014/main" id="{13FEDD19-82FD-A328-805E-EAE2633FCF1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191312" y="2183833"/>
            <a:ext cx="7240623" cy="5430466"/>
          </a:xfrm>
        </p:spPr>
      </p:pic>
    </p:spTree>
    <p:extLst>
      <p:ext uri="{BB962C8B-B14F-4D97-AF65-F5344CB8AC3E}">
        <p14:creationId xmlns:p14="http://schemas.microsoft.com/office/powerpoint/2010/main" val="19942249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973B34-2F15-1F46-828D-D87BBD20F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015936"/>
          </a:xfrm>
        </p:spPr>
        <p:txBody>
          <a:bodyPr>
            <a:normAutofit/>
          </a:bodyPr>
          <a:lstStyle/>
          <a:p>
            <a:r>
              <a:rPr lang="en-US" sz="2000" b="1" dirty="0"/>
              <a:t>Fig 6D.  2010 notebook scan, tissue harvest.  </a:t>
            </a:r>
          </a:p>
        </p:txBody>
      </p:sp>
      <p:pic>
        <p:nvPicPr>
          <p:cNvPr id="5" name="Content Placeholder 4" descr="A close-up of a graph&#10;&#10;Description automatically generated">
            <a:extLst>
              <a:ext uri="{FF2B5EF4-FFF2-40B4-BE49-F238E27FC236}">
                <a16:creationId xmlns:a16="http://schemas.microsoft.com/office/drawing/2014/main" id="{8717D1A5-A5A1-5A69-EB01-A0FED44E323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984" y="1502773"/>
            <a:ext cx="5345217" cy="7126956"/>
          </a:xfrm>
        </p:spPr>
      </p:pic>
    </p:spTree>
    <p:extLst>
      <p:ext uri="{BB962C8B-B14F-4D97-AF65-F5344CB8AC3E}">
        <p14:creationId xmlns:p14="http://schemas.microsoft.com/office/powerpoint/2010/main" val="28162856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close-up of a piece of paper&#10;&#10;Description automatically generated">
            <a:extLst>
              <a:ext uri="{FF2B5EF4-FFF2-40B4-BE49-F238E27FC236}">
                <a16:creationId xmlns:a16="http://schemas.microsoft.com/office/drawing/2014/main" id="{C22C889A-164F-06D1-6E25-7A427B69BB8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3133" y="2433638"/>
            <a:ext cx="4351734" cy="5802312"/>
          </a:xfr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E9AA3198-7D15-76DE-49C2-05816EBAD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7363"/>
            <a:ext cx="5915025" cy="1766887"/>
          </a:xfrm>
        </p:spPr>
        <p:txBody>
          <a:bodyPr>
            <a:normAutofit/>
          </a:bodyPr>
          <a:lstStyle/>
          <a:p>
            <a:r>
              <a:rPr lang="en-US" sz="2000" b="1" dirty="0"/>
              <a:t>Fig 6D.  2010  notebook scan on TUNEL staining. Raw counts provided in Excel.</a:t>
            </a:r>
          </a:p>
        </p:txBody>
      </p:sp>
    </p:spTree>
    <p:extLst>
      <p:ext uri="{BB962C8B-B14F-4D97-AF65-F5344CB8AC3E}">
        <p14:creationId xmlns:p14="http://schemas.microsoft.com/office/powerpoint/2010/main" val="30773066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176942-7928-29D7-2ED5-169403AB4E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61992"/>
            <a:ext cx="5915025" cy="1053865"/>
          </a:xfrm>
        </p:spPr>
        <p:txBody>
          <a:bodyPr>
            <a:normAutofit/>
          </a:bodyPr>
          <a:lstStyle/>
          <a:p>
            <a:r>
              <a:rPr lang="en-US" sz="2000" b="1" dirty="0"/>
              <a:t>Fig 6D. 2010 notebook scan on </a:t>
            </a:r>
            <a:r>
              <a:rPr lang="en-US" sz="2000" b="1" dirty="0" err="1"/>
              <a:t>BrdU</a:t>
            </a:r>
            <a:r>
              <a:rPr lang="en-US" sz="2000" b="1" dirty="0"/>
              <a:t> staining. Raw counts provided in Excel. </a:t>
            </a:r>
          </a:p>
        </p:txBody>
      </p:sp>
      <p:pic>
        <p:nvPicPr>
          <p:cNvPr id="5" name="Content Placeholder 4" descr="A close-up of a notebook&#10;&#10;Description automatically generated">
            <a:extLst>
              <a:ext uri="{FF2B5EF4-FFF2-40B4-BE49-F238E27FC236}">
                <a16:creationId xmlns:a16="http://schemas.microsoft.com/office/drawing/2014/main" id="{E9E101E9-C755-8AF3-B8CC-0FC9AE05C35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596"/>
          <a:stretch/>
        </p:blipFill>
        <p:spPr>
          <a:xfrm>
            <a:off x="812962" y="1824437"/>
            <a:ext cx="5573551" cy="6569680"/>
          </a:xfrm>
        </p:spPr>
      </p:pic>
    </p:spTree>
    <p:extLst>
      <p:ext uri="{BB962C8B-B14F-4D97-AF65-F5344CB8AC3E}">
        <p14:creationId xmlns:p14="http://schemas.microsoft.com/office/powerpoint/2010/main" val="29408125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C5ACD0-117A-B663-4D92-9614E8398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647997"/>
            <a:ext cx="5915025" cy="992912"/>
          </a:xfrm>
        </p:spPr>
        <p:txBody>
          <a:bodyPr>
            <a:normAutofit/>
          </a:bodyPr>
          <a:lstStyle/>
          <a:p>
            <a:r>
              <a:rPr lang="en-US" sz="2000" dirty="0"/>
              <a:t>Fig. 6B.  2011 notebook scan for mouse experiments on tissues harvest.</a:t>
            </a:r>
          </a:p>
        </p:txBody>
      </p:sp>
      <p:pic>
        <p:nvPicPr>
          <p:cNvPr id="5" name="Content Placeholder 4" descr="A close-up of a graph&#10;&#10;Description automatically generated">
            <a:extLst>
              <a:ext uri="{FF2B5EF4-FFF2-40B4-BE49-F238E27FC236}">
                <a16:creationId xmlns:a16="http://schemas.microsoft.com/office/drawing/2014/main" id="{2ED0A3A9-46CF-34A0-AC3B-B8F44CE47E0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63"/>
          <a:stretch/>
        </p:blipFill>
        <p:spPr>
          <a:xfrm>
            <a:off x="584221" y="1678488"/>
            <a:ext cx="5431812" cy="6803311"/>
          </a:xfrm>
        </p:spPr>
      </p:pic>
    </p:spTree>
    <p:extLst>
      <p:ext uri="{BB962C8B-B14F-4D97-AF65-F5344CB8AC3E}">
        <p14:creationId xmlns:p14="http://schemas.microsoft.com/office/powerpoint/2010/main" val="24750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1</TotalTime>
  <Words>226</Words>
  <Application>Microsoft Office PowerPoint</Application>
  <PresentationFormat>On-screen Show (4:3)</PresentationFormat>
  <Paragraphs>28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ArialMT</vt:lpstr>
      <vt:lpstr>Calibri</vt:lpstr>
      <vt:lpstr>Calibri Light</vt:lpstr>
      <vt:lpstr>Office Theme</vt:lpstr>
      <vt:lpstr>Primary data 2  film scans, notebook scans, gel images </vt:lpstr>
      <vt:lpstr>Fig. 6B Correction.  Film scan and later experiment</vt:lpstr>
      <vt:lpstr>PowerPoint Presentation</vt:lpstr>
      <vt:lpstr>Fig. 6A. 2010, notebook scan on mouse experiments. After q-PCR in Fig. 1C</vt:lpstr>
      <vt:lpstr>Fig. 6A.  2010 notebook scan, buffer prep for mouse experiments</vt:lpstr>
      <vt:lpstr>Fig 6D.  2010 notebook scan, tissue harvest.  </vt:lpstr>
      <vt:lpstr>Fig 6D.  2010  notebook scan on TUNEL staining. Raw counts provided in Excel.</vt:lpstr>
      <vt:lpstr>Fig 6D. 2010 notebook scan on BrdU staining. Raw counts provided in Excel. </vt:lpstr>
      <vt:lpstr>Fig. 6B.  2011 notebook scan for mouse experiments on tissues harvest.</vt:lpstr>
      <vt:lpstr>Additional primary data on Figures Fig 3A, S2 and 4A.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24 0118 quanhong</dc:title>
  <dc:creator>Jian Yu</dc:creator>
  <cp:lastModifiedBy>Jian Yu</cp:lastModifiedBy>
  <cp:revision>3</cp:revision>
  <dcterms:created xsi:type="dcterms:W3CDTF">2024-01-19T18:53:00Z</dcterms:created>
  <dcterms:modified xsi:type="dcterms:W3CDTF">2024-03-15T17:27:20Z</dcterms:modified>
</cp:coreProperties>
</file>